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77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793"/>
    <p:restoredTop sz="94626"/>
  </p:normalViewPr>
  <p:slideViewPr>
    <p:cSldViewPr snapToGrid="0">
      <p:cViewPr varScale="1">
        <p:scale>
          <a:sx n="121" d="100"/>
          <a:sy n="121" d="100"/>
        </p:scale>
        <p:origin x="8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7C4198-5332-D643-A5F7-5797AD75E297}" type="datetimeFigureOut">
              <a:rPr lang="en-US" smtClean="0"/>
              <a:t>2/16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0F1977-EC3B-5745-91DB-284F4D58A0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5722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593C62C-157A-B478-7221-3F08F9C5BB9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1A26AF1E-A5DC-4C4A-8229-A61521E0D57B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F7976072-F2D2-AB34-BB8B-2BA14C06F05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6D0B010-ED92-67AC-CEFA-BC177E015267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1DB352-6277-CF49-916A-394B201FA12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7170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88EABC-DD8A-25D1-9237-45815CE70BC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BE7379C-9837-DF5C-3D82-6175BDA51E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6A7C74-7723-40D4-58C3-F622E73428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E801C-ED2C-A34A-A8C1-D4E68ABBFC60}" type="datetimeFigureOut">
              <a:rPr lang="en-US" smtClean="0"/>
              <a:t>2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6935F1-EA4B-C88E-679C-164ACE234D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C69D91-907D-27C8-23B2-1B1C9AEDA0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22B90-57BD-374D-955E-FC46005EE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571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87688A-B495-2582-7A11-021D3DB69B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3659EA9-7768-99CF-3E20-5496304EFA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5DCD77-1416-7D10-A550-9CF30D2E2F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E801C-ED2C-A34A-A8C1-D4E68ABBFC60}" type="datetimeFigureOut">
              <a:rPr lang="en-US" smtClean="0"/>
              <a:t>2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0447D8-2428-0AC8-8CF1-6398AF46F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965072-4403-35C2-8F78-A268C1A201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22B90-57BD-374D-955E-FC46005EE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9013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FCE5DB0-258E-BC19-5287-86D6028A56E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11E7D88-1A43-B09A-C2FD-F6C8ECC174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AC387C-94BC-1495-EA08-EE6E4CCCA9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E801C-ED2C-A34A-A8C1-D4E68ABBFC60}" type="datetimeFigureOut">
              <a:rPr lang="en-US" smtClean="0"/>
              <a:t>2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F1AEF9-3A02-CC43-4679-045FC82C47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5EFD08-EA85-C6DF-96E7-8649A2F26A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22B90-57BD-374D-955E-FC46005EE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0251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A4BE1C-3C7A-EBB6-B873-6ED5344F2F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14506B-F8A1-C6BA-79D4-FE1AA283F26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8FCFE2-A523-E85C-9292-9F399B8160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E801C-ED2C-A34A-A8C1-D4E68ABBFC60}" type="datetimeFigureOut">
              <a:rPr lang="en-US" smtClean="0"/>
              <a:t>2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DA634A-D665-3F29-97FE-7A26578D9E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55F5F0-0C22-155E-E5D6-53B30569E0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22B90-57BD-374D-955E-FC46005EE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1483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BCB5CD-08E7-3F67-43E4-86C3251770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1E518D-5C96-61C7-6186-0499ACC63B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E5A22A-9F79-C590-995E-B750D4A720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E801C-ED2C-A34A-A8C1-D4E68ABBFC60}" type="datetimeFigureOut">
              <a:rPr lang="en-US" smtClean="0"/>
              <a:t>2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1E9465-9B9E-ACC5-3FF7-95C5EB45A5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DB4615-BCC5-F0E2-E299-F196508D53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22B90-57BD-374D-955E-FC46005EE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82101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2BBE7A-13C3-FF7D-E12F-1EA3A72604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F3CC46-CC9F-8DCE-3A0F-9CEF8CD56C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1092697-81FA-C970-ADA5-9E54AFC282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BFF88E-A22E-5687-E024-3783B24EAF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E801C-ED2C-A34A-A8C1-D4E68ABBFC60}" type="datetimeFigureOut">
              <a:rPr lang="en-US" smtClean="0"/>
              <a:t>2/1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5B00F4-5B7E-D292-9863-1BE0442F61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B30487-9F97-C83B-D4B0-0147F4ED1E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22B90-57BD-374D-955E-FC46005EE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909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8B4EAB-A337-82A7-0CA1-C36F29257D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7FA9BF-B992-A0E2-1449-246459DD9E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349EF4-784F-18EF-B00B-7FAB3711D5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014FD31-B774-E581-E0D9-4152ECCC85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14B5A9E-7F34-0150-9A41-1E2B6AACF1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483B187-16A5-4302-1CD2-2161E084D7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E801C-ED2C-A34A-A8C1-D4E68ABBFC60}" type="datetimeFigureOut">
              <a:rPr lang="en-US" smtClean="0"/>
              <a:t>2/16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9867FD1-114E-4829-74A1-E024CDE8D0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E3270FA-1772-F8ED-3CA9-CA66BEFADB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22B90-57BD-374D-955E-FC46005EE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691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CF1D8A-328C-06FC-2B81-D0909E3074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016F7FC-14CF-F052-0271-BF8E6592BB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E801C-ED2C-A34A-A8C1-D4E68ABBFC60}" type="datetimeFigureOut">
              <a:rPr lang="en-US" smtClean="0"/>
              <a:t>2/16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FE6E594-C6A8-5D18-6239-8BF01FD1CE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A59C11A-DE3D-7E1C-1F2F-580DFA802B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22B90-57BD-374D-955E-FC46005EE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1160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AF91FA7-8DEB-F357-1FBF-B4C521AE6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E801C-ED2C-A34A-A8C1-D4E68ABBFC60}" type="datetimeFigureOut">
              <a:rPr lang="en-US" smtClean="0"/>
              <a:t>2/16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DD04B87-DB7F-6A92-1475-BE196D2D0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43BBC45-595A-DFDC-DAE8-946A27EE1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22B90-57BD-374D-955E-FC46005EE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885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B9A6E0-44C2-E77E-4D11-6811FC7609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1CB401-2EDB-CE65-429E-F9902DCEF1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0F8954-C967-E363-872B-45920209CA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E63D84-92F6-28EF-6D78-F11E17826E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E801C-ED2C-A34A-A8C1-D4E68ABBFC60}" type="datetimeFigureOut">
              <a:rPr lang="en-US" smtClean="0"/>
              <a:t>2/1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D613B4-4CCC-2132-C490-E56791E288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7E6F05-4E3C-E216-AB2A-98C74A132A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22B90-57BD-374D-955E-FC46005EE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635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05D9FB-F1D8-838B-CA75-697624FCAD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240611B-4D0A-3078-9CD7-E95DEB1D7C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41DBF1-3B8B-30E1-0DE0-BB1552AC18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B3B4E3-9C0A-E858-DE53-EE7FFD4950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E801C-ED2C-A34A-A8C1-D4E68ABBFC60}" type="datetimeFigureOut">
              <a:rPr lang="en-US" smtClean="0"/>
              <a:t>2/1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B58B00-1647-CA2C-3171-990DD633B2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3E549F-95F2-57AD-96C8-07E247A131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22B90-57BD-374D-955E-FC46005EE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739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3F44E3A-268B-9586-679A-C4D4CA081B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ADE68D-5928-8B57-69D4-6DA74B2B9A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45DCA2-D596-7F6F-8A95-4433431EF7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DE801C-ED2C-A34A-A8C1-D4E68ABBFC60}" type="datetimeFigureOut">
              <a:rPr lang="en-US" smtClean="0"/>
              <a:t>2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212D25-3A90-075A-D1B3-3BFD4FD54E5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E6C78B-3176-0986-BDF8-3D4E9F2B9F8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122B90-57BD-374D-955E-FC46005EE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00469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5" Type="http://schemas.microsoft.com/office/2007/relationships/hdphoto" Target="../media/hdphoto1.wdp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8E4C2B1-264E-9444-E0E3-D8511A76973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>
            <a:extLst>
              <a:ext uri="{FF2B5EF4-FFF2-40B4-BE49-F238E27FC236}">
                <a16:creationId xmlns:a16="http://schemas.microsoft.com/office/drawing/2014/main" id="{34F9418B-03C6-B0DF-5124-07441D951ABD}"/>
              </a:ext>
            </a:extLst>
          </p:cNvPr>
          <p:cNvSpPr txBox="1"/>
          <p:nvPr/>
        </p:nvSpPr>
        <p:spPr>
          <a:xfrm>
            <a:off x="4621467" y="5993563"/>
            <a:ext cx="23084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IP:anti-HA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IB:anti-HA</a:t>
            </a:r>
            <a:endParaRPr lang="en-US" sz="16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C973BD8-6A68-C40E-2F2E-F64603EFBE9C}"/>
              </a:ext>
            </a:extLst>
          </p:cNvPr>
          <p:cNvSpPr txBox="1"/>
          <p:nvPr/>
        </p:nvSpPr>
        <p:spPr>
          <a:xfrm>
            <a:off x="-43045" y="-55189"/>
            <a:ext cx="37018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Figure 2B, HA-APP</a:t>
            </a:r>
            <a:r>
              <a:rPr lang="en-US" sz="2000" baseline="-25000" dirty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(Full blot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FB920E7-3174-27B5-EBA8-1F6D9158D04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912" t="8637" r="18453" b="2326"/>
          <a:stretch/>
        </p:blipFill>
        <p:spPr>
          <a:xfrm flipH="1">
            <a:off x="4299399" y="771523"/>
            <a:ext cx="4798993" cy="5251909"/>
          </a:xfrm>
          <a:prstGeom prst="rect">
            <a:avLst/>
          </a:prstGeom>
        </p:spPr>
      </p:pic>
      <p:sp>
        <p:nvSpPr>
          <p:cNvPr id="36" name="Rectangle 35">
            <a:extLst>
              <a:ext uri="{FF2B5EF4-FFF2-40B4-BE49-F238E27FC236}">
                <a16:creationId xmlns:a16="http://schemas.microsoft.com/office/drawing/2014/main" id="{1BCDEF49-22D1-D5C4-A6F4-EA409D96F1AC}"/>
              </a:ext>
            </a:extLst>
          </p:cNvPr>
          <p:cNvSpPr/>
          <p:nvPr/>
        </p:nvSpPr>
        <p:spPr>
          <a:xfrm>
            <a:off x="4298630" y="750388"/>
            <a:ext cx="3538522" cy="5251908"/>
          </a:xfrm>
          <a:prstGeom prst="rect">
            <a:avLst/>
          </a:prstGeom>
          <a:noFill/>
          <a:ln w="4445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55D90A-1C3F-3987-81AF-DC053800D855}"/>
              </a:ext>
            </a:extLst>
          </p:cNvPr>
          <p:cNvSpPr txBox="1"/>
          <p:nvPr/>
        </p:nvSpPr>
        <p:spPr>
          <a:xfrm>
            <a:off x="4332055" y="399855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ve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E9DFB26-48DC-D2F9-219C-CE92C79A0305}"/>
              </a:ext>
            </a:extLst>
          </p:cNvPr>
          <p:cNvSpPr txBox="1"/>
          <p:nvPr/>
        </p:nvSpPr>
        <p:spPr>
          <a:xfrm>
            <a:off x="4896309" y="399855"/>
            <a:ext cx="3741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5F7570C-C1E9-531C-C36A-3F526E4C5372}"/>
              </a:ext>
            </a:extLst>
          </p:cNvPr>
          <p:cNvSpPr txBox="1"/>
          <p:nvPr/>
        </p:nvSpPr>
        <p:spPr>
          <a:xfrm>
            <a:off x="5322860" y="408730"/>
            <a:ext cx="6367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133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F0C4EF4-FF02-07CF-60BB-53E801565C61}"/>
              </a:ext>
            </a:extLst>
          </p:cNvPr>
          <p:cNvSpPr txBox="1"/>
          <p:nvPr/>
        </p:nvSpPr>
        <p:spPr>
          <a:xfrm>
            <a:off x="5890742" y="399855"/>
            <a:ext cx="6576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158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68D35E6-B17E-BE8E-0851-C541E9214B27}"/>
              </a:ext>
            </a:extLst>
          </p:cNvPr>
          <p:cNvSpPr txBox="1"/>
          <p:nvPr/>
        </p:nvSpPr>
        <p:spPr>
          <a:xfrm>
            <a:off x="6470622" y="400621"/>
            <a:ext cx="6367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186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F99310A-1596-6117-D3C2-9C7347B24A10}"/>
              </a:ext>
            </a:extLst>
          </p:cNvPr>
          <p:cNvSpPr txBox="1"/>
          <p:nvPr/>
        </p:nvSpPr>
        <p:spPr>
          <a:xfrm>
            <a:off x="7107524" y="402924"/>
            <a:ext cx="6367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187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083A0E4-975B-151D-0063-416310CB0217}"/>
              </a:ext>
            </a:extLst>
          </p:cNvPr>
          <p:cNvSpPr txBox="1"/>
          <p:nvPr/>
        </p:nvSpPr>
        <p:spPr>
          <a:xfrm>
            <a:off x="2935776" y="1637390"/>
            <a:ext cx="10374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A-APP</a:t>
            </a:r>
            <a:r>
              <a:rPr lang="en-US" sz="1600" baseline="-25000" dirty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DFB42A3D-F946-450A-52DB-64B69511CA99}"/>
              </a:ext>
            </a:extLst>
          </p:cNvPr>
          <p:cNvCxnSpPr>
            <a:cxnSpLocks/>
          </p:cNvCxnSpPr>
          <p:nvPr/>
        </p:nvCxnSpPr>
        <p:spPr>
          <a:xfrm>
            <a:off x="3937504" y="1812615"/>
            <a:ext cx="210065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783760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1231FC2B-B66E-D03E-D183-D5E0F66F58B6}"/>
              </a:ext>
            </a:extLst>
          </p:cNvPr>
          <p:cNvSpPr txBox="1"/>
          <p:nvPr/>
        </p:nvSpPr>
        <p:spPr>
          <a:xfrm>
            <a:off x="1674580" y="1022164"/>
            <a:ext cx="1069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6A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F2869E9B-53D8-6DED-2E8E-58C0335ED29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4278" y="1643619"/>
            <a:ext cx="4550002" cy="434164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7CE2183C-498A-5F91-4928-DF4596E714D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5528"/>
          <a:stretch/>
        </p:blipFill>
        <p:spPr>
          <a:xfrm>
            <a:off x="6004307" y="1659378"/>
            <a:ext cx="2686829" cy="4266303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BD878FD9-4BF9-03D7-F319-83FD59BE7521}"/>
              </a:ext>
            </a:extLst>
          </p:cNvPr>
          <p:cNvSpPr txBox="1"/>
          <p:nvPr/>
        </p:nvSpPr>
        <p:spPr>
          <a:xfrm>
            <a:off x="294278" y="5942972"/>
            <a:ext cx="2312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P: anti-HA, IB: anti-V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844CB1B-9DC2-942C-C563-84826199DF96}"/>
              </a:ext>
            </a:extLst>
          </p:cNvPr>
          <p:cNvSpPr txBox="1"/>
          <p:nvPr/>
        </p:nvSpPr>
        <p:spPr>
          <a:xfrm>
            <a:off x="5967252" y="6005054"/>
            <a:ext cx="38893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P: anti-</a:t>
            </a:r>
            <a:r>
              <a:rPr lang="en-US" dirty="0" err="1"/>
              <a:t>mGFP</a:t>
            </a:r>
            <a:r>
              <a:rPr lang="en-US" dirty="0"/>
              <a:t>, IB: anti-</a:t>
            </a:r>
            <a:r>
              <a:rPr lang="en-US" dirty="0" err="1"/>
              <a:t>mCherry</a:t>
            </a:r>
            <a:endParaRPr lang="en-US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FCFE58D5-2618-1FAB-894D-5237B65CECB7}"/>
              </a:ext>
            </a:extLst>
          </p:cNvPr>
          <p:cNvSpPr/>
          <p:nvPr/>
        </p:nvSpPr>
        <p:spPr>
          <a:xfrm>
            <a:off x="1654879" y="2419628"/>
            <a:ext cx="1256474" cy="914400"/>
          </a:xfrm>
          <a:prstGeom prst="rect">
            <a:avLst/>
          </a:prstGeom>
          <a:noFill/>
          <a:ln w="4445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A4895A46-A87B-0301-EC8A-732C40C99E83}"/>
              </a:ext>
            </a:extLst>
          </p:cNvPr>
          <p:cNvSpPr/>
          <p:nvPr/>
        </p:nvSpPr>
        <p:spPr>
          <a:xfrm>
            <a:off x="1654879" y="4138940"/>
            <a:ext cx="1184427" cy="914400"/>
          </a:xfrm>
          <a:prstGeom prst="rect">
            <a:avLst/>
          </a:prstGeom>
          <a:noFill/>
          <a:ln w="4445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9FD47C74-51FE-F039-575A-696E74D82A91}"/>
              </a:ext>
            </a:extLst>
          </p:cNvPr>
          <p:cNvSpPr/>
          <p:nvPr/>
        </p:nvSpPr>
        <p:spPr>
          <a:xfrm>
            <a:off x="6401745" y="2301206"/>
            <a:ext cx="1432648" cy="914400"/>
          </a:xfrm>
          <a:prstGeom prst="rect">
            <a:avLst/>
          </a:prstGeom>
          <a:noFill/>
          <a:ln w="4445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C124685-3BF1-5EAD-17BA-19440A5EC41A}"/>
              </a:ext>
            </a:extLst>
          </p:cNvPr>
          <p:cNvSpPr txBox="1"/>
          <p:nvPr/>
        </p:nvSpPr>
        <p:spPr>
          <a:xfrm>
            <a:off x="1963450" y="1911796"/>
            <a:ext cx="8730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Cer</a:t>
            </a:r>
            <a:r>
              <a:rPr lang="en-US" sz="1200" dirty="0"/>
              <a:t>(</a:t>
            </a:r>
            <a:r>
              <a:rPr lang="en-US" sz="1200" dirty="0">
                <a:latin typeface="Symbol" pitchFamily="2" charset="2"/>
              </a:rPr>
              <a:t>m</a:t>
            </a:r>
            <a:r>
              <a:rPr lang="en-US" sz="1200" dirty="0"/>
              <a:t>g/ml)</a:t>
            </a:r>
            <a:endParaRPr lang="en-US" sz="1200" baseline="-250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FA4298B-DAC6-68F2-929E-549E12D496A8}"/>
              </a:ext>
            </a:extLst>
          </p:cNvPr>
          <p:cNvSpPr txBox="1"/>
          <p:nvPr/>
        </p:nvSpPr>
        <p:spPr>
          <a:xfrm>
            <a:off x="1888916" y="2184575"/>
            <a:ext cx="1095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0   25  50  100</a:t>
            </a:r>
            <a:endParaRPr lang="en-US" sz="1200" baseline="-25000" dirty="0"/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72E7934D-8DCD-ADBF-F7A8-92597ED08A9B}"/>
              </a:ext>
            </a:extLst>
          </p:cNvPr>
          <p:cNvCxnSpPr/>
          <p:nvPr/>
        </p:nvCxnSpPr>
        <p:spPr>
          <a:xfrm>
            <a:off x="1888916" y="2227123"/>
            <a:ext cx="94759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59F64D9A-7EF7-26D1-4A55-943C4C9FA053}"/>
              </a:ext>
            </a:extLst>
          </p:cNvPr>
          <p:cNvSpPr txBox="1"/>
          <p:nvPr/>
        </p:nvSpPr>
        <p:spPr>
          <a:xfrm>
            <a:off x="1760400" y="1639891"/>
            <a:ext cx="11120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PPV5+APPHA</a:t>
            </a:r>
            <a:endParaRPr lang="en-US" sz="1200" baseline="-25000" dirty="0"/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DD419DF2-6B63-0E0A-3427-A33874A0F74B}"/>
              </a:ext>
            </a:extLst>
          </p:cNvPr>
          <p:cNvCxnSpPr/>
          <p:nvPr/>
        </p:nvCxnSpPr>
        <p:spPr>
          <a:xfrm>
            <a:off x="1888916" y="1905675"/>
            <a:ext cx="94759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FB93DEDF-16B6-E0AB-A42E-ABB77B981BAA}"/>
              </a:ext>
            </a:extLst>
          </p:cNvPr>
          <p:cNvSpPr txBox="1"/>
          <p:nvPr/>
        </p:nvSpPr>
        <p:spPr>
          <a:xfrm>
            <a:off x="810076" y="4509124"/>
            <a:ext cx="578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FV5</a:t>
            </a:r>
            <a:endParaRPr lang="en-US" sz="1200" baseline="-250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E1545A1-8B45-ADAC-99BB-8027ED0ED517}"/>
              </a:ext>
            </a:extLst>
          </p:cNvPr>
          <p:cNvSpPr txBox="1"/>
          <p:nvPr/>
        </p:nvSpPr>
        <p:spPr>
          <a:xfrm>
            <a:off x="810076" y="2749820"/>
            <a:ext cx="5990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PPV5</a:t>
            </a:r>
            <a:endParaRPr lang="en-US" sz="1200" baseline="-250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86C5276-A35F-83C2-637C-A8D72381809F}"/>
              </a:ext>
            </a:extLst>
          </p:cNvPr>
          <p:cNvSpPr txBox="1"/>
          <p:nvPr/>
        </p:nvSpPr>
        <p:spPr>
          <a:xfrm>
            <a:off x="6401745" y="1676669"/>
            <a:ext cx="17133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APP-mGFP+APPmCherry</a:t>
            </a:r>
            <a:endParaRPr lang="en-US" sz="1200" baseline="-25000" dirty="0"/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C2806647-6F4D-7ABE-056E-61C872541E57}"/>
              </a:ext>
            </a:extLst>
          </p:cNvPr>
          <p:cNvCxnSpPr/>
          <p:nvPr/>
        </p:nvCxnSpPr>
        <p:spPr>
          <a:xfrm>
            <a:off x="6646662" y="1986493"/>
            <a:ext cx="94759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EF8EC4F0-FC75-7E2F-D3F8-C75DFC38D31A}"/>
              </a:ext>
            </a:extLst>
          </p:cNvPr>
          <p:cNvSpPr txBox="1"/>
          <p:nvPr/>
        </p:nvSpPr>
        <p:spPr>
          <a:xfrm>
            <a:off x="6455066" y="1950398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MSO</a:t>
            </a:r>
            <a:endParaRPr lang="en-US" sz="1200" baseline="-250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DFF2062-CDC4-E737-ADEE-B0A33DB1847E}"/>
              </a:ext>
            </a:extLst>
          </p:cNvPr>
          <p:cNvSpPr txBox="1"/>
          <p:nvPr/>
        </p:nvSpPr>
        <p:spPr>
          <a:xfrm>
            <a:off x="7262882" y="1938365"/>
            <a:ext cx="3962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Cer</a:t>
            </a:r>
            <a:endParaRPr lang="en-US" sz="1200" baseline="-25000" dirty="0"/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EC1EA252-ABA4-4983-61D0-752A944CBEF3}"/>
              </a:ext>
            </a:extLst>
          </p:cNvPr>
          <p:cNvCxnSpPr>
            <a:cxnSpLocks/>
          </p:cNvCxnSpPr>
          <p:nvPr/>
        </p:nvCxnSpPr>
        <p:spPr>
          <a:xfrm>
            <a:off x="6463862" y="2202332"/>
            <a:ext cx="57501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03DB72EB-3DE2-ABEB-4E89-2B03FFA02757}"/>
              </a:ext>
            </a:extLst>
          </p:cNvPr>
          <p:cNvCxnSpPr>
            <a:cxnSpLocks/>
          </p:cNvCxnSpPr>
          <p:nvPr/>
        </p:nvCxnSpPr>
        <p:spPr>
          <a:xfrm>
            <a:off x="7173504" y="2193161"/>
            <a:ext cx="57501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A8CFD183-2646-3E3A-6E05-9C62A02E088F}"/>
              </a:ext>
            </a:extLst>
          </p:cNvPr>
          <p:cNvSpPr txBox="1"/>
          <p:nvPr/>
        </p:nvSpPr>
        <p:spPr>
          <a:xfrm>
            <a:off x="5123490" y="2517274"/>
            <a:ext cx="9725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APPmCherry</a:t>
            </a:r>
            <a:endParaRPr lang="en-US" sz="1200" baseline="-250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FEFB366-4DFE-8412-D7FD-A8351E500F1B}"/>
              </a:ext>
            </a:extLst>
          </p:cNvPr>
          <p:cNvSpPr txBox="1"/>
          <p:nvPr/>
        </p:nvSpPr>
        <p:spPr>
          <a:xfrm>
            <a:off x="5122313" y="3689903"/>
            <a:ext cx="9508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CTFmCherry</a:t>
            </a:r>
            <a:endParaRPr lang="en-US" sz="1200" baseline="-25000" dirty="0"/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0FF8BB33-2C1A-B39C-942F-42670916197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rcRect l="45603"/>
          <a:stretch/>
        </p:blipFill>
        <p:spPr>
          <a:xfrm>
            <a:off x="8780514" y="1651104"/>
            <a:ext cx="2686829" cy="4274577"/>
          </a:xfrm>
          <a:prstGeom prst="rect">
            <a:avLst/>
          </a:prstGeom>
        </p:spPr>
      </p:pic>
      <p:sp>
        <p:nvSpPr>
          <p:cNvPr id="21" name="Rectangle 20">
            <a:extLst>
              <a:ext uri="{FF2B5EF4-FFF2-40B4-BE49-F238E27FC236}">
                <a16:creationId xmlns:a16="http://schemas.microsoft.com/office/drawing/2014/main" id="{B887837D-5413-7958-9497-A5B7FA8642A3}"/>
              </a:ext>
            </a:extLst>
          </p:cNvPr>
          <p:cNvSpPr/>
          <p:nvPr/>
        </p:nvSpPr>
        <p:spPr>
          <a:xfrm>
            <a:off x="9080938" y="3356337"/>
            <a:ext cx="1551359" cy="914400"/>
          </a:xfrm>
          <a:prstGeom prst="rect">
            <a:avLst/>
          </a:prstGeom>
          <a:noFill/>
          <a:ln w="4445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D67E8B8-D865-F98C-26A9-7C0369C47229}"/>
              </a:ext>
            </a:extLst>
          </p:cNvPr>
          <p:cNvSpPr txBox="1"/>
          <p:nvPr/>
        </p:nvSpPr>
        <p:spPr>
          <a:xfrm>
            <a:off x="6004307" y="5573640"/>
            <a:ext cx="18376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horter exposur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10CD974-11AB-07CB-070E-5601A21443F9}"/>
              </a:ext>
            </a:extLst>
          </p:cNvPr>
          <p:cNvSpPr txBox="1"/>
          <p:nvPr/>
        </p:nvSpPr>
        <p:spPr>
          <a:xfrm>
            <a:off x="8741901" y="5556349"/>
            <a:ext cx="17793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Longer exposur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F8E6264-D45D-B7C7-98A4-449CFD4B950B}"/>
              </a:ext>
            </a:extLst>
          </p:cNvPr>
          <p:cNvSpPr txBox="1"/>
          <p:nvPr/>
        </p:nvSpPr>
        <p:spPr>
          <a:xfrm>
            <a:off x="0" y="18203"/>
            <a:ext cx="34714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Figure 6 Top Gels (Full blots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22ADD72-BA0A-EA52-97FD-977C29284C9A}"/>
              </a:ext>
            </a:extLst>
          </p:cNvPr>
          <p:cNvSpPr txBox="1"/>
          <p:nvPr/>
        </p:nvSpPr>
        <p:spPr>
          <a:xfrm>
            <a:off x="8074899" y="943848"/>
            <a:ext cx="1061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6B</a:t>
            </a:r>
          </a:p>
        </p:txBody>
      </p:sp>
    </p:spTree>
    <p:extLst>
      <p:ext uri="{BB962C8B-B14F-4D97-AF65-F5344CB8AC3E}">
        <p14:creationId xmlns:p14="http://schemas.microsoft.com/office/powerpoint/2010/main" val="10829187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close up of a dna&#10;&#10;Description automatically generated">
            <a:extLst>
              <a:ext uri="{FF2B5EF4-FFF2-40B4-BE49-F238E27FC236}">
                <a16:creationId xmlns:a16="http://schemas.microsoft.com/office/drawing/2014/main" id="{D073C04C-7D5D-3E64-1BE0-5FE4C7E9B48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48768"/>
          <a:stretch/>
        </p:blipFill>
        <p:spPr>
          <a:xfrm flipH="1">
            <a:off x="1638430" y="1112580"/>
            <a:ext cx="3278915" cy="5411451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7ADEEEE3-BF48-FF10-DAEF-86B0A5D3513A}"/>
              </a:ext>
            </a:extLst>
          </p:cNvPr>
          <p:cNvSpPr/>
          <p:nvPr/>
        </p:nvSpPr>
        <p:spPr>
          <a:xfrm>
            <a:off x="2215389" y="2167493"/>
            <a:ext cx="1361358" cy="914400"/>
          </a:xfrm>
          <a:prstGeom prst="rect">
            <a:avLst/>
          </a:prstGeom>
          <a:noFill/>
          <a:ln w="4445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DF934F6-497D-41A9-E1A3-4A2DCCB3FB71}"/>
              </a:ext>
            </a:extLst>
          </p:cNvPr>
          <p:cNvSpPr/>
          <p:nvPr/>
        </p:nvSpPr>
        <p:spPr>
          <a:xfrm>
            <a:off x="2216776" y="3462893"/>
            <a:ext cx="1365750" cy="914400"/>
          </a:xfrm>
          <a:prstGeom prst="rect">
            <a:avLst/>
          </a:prstGeom>
          <a:noFill/>
          <a:ln w="4445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5D6018D-5CC9-52BB-8E56-C782FE07058A}"/>
              </a:ext>
            </a:extLst>
          </p:cNvPr>
          <p:cNvSpPr txBox="1"/>
          <p:nvPr/>
        </p:nvSpPr>
        <p:spPr>
          <a:xfrm>
            <a:off x="2504466" y="1643420"/>
            <a:ext cx="8730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Cer</a:t>
            </a:r>
            <a:r>
              <a:rPr lang="en-US" sz="1200" dirty="0"/>
              <a:t>(</a:t>
            </a:r>
            <a:r>
              <a:rPr lang="en-US" sz="1200" dirty="0">
                <a:latin typeface="Symbol" pitchFamily="2" charset="2"/>
              </a:rPr>
              <a:t>m</a:t>
            </a:r>
            <a:r>
              <a:rPr lang="en-US" sz="1200" dirty="0"/>
              <a:t>g/ml)</a:t>
            </a:r>
            <a:endParaRPr lang="en-US" sz="1200" baseline="-250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19FE940-22F4-07DC-292C-BB97DAADB4C8}"/>
              </a:ext>
            </a:extLst>
          </p:cNvPr>
          <p:cNvSpPr txBox="1"/>
          <p:nvPr/>
        </p:nvSpPr>
        <p:spPr>
          <a:xfrm>
            <a:off x="2305245" y="1874106"/>
            <a:ext cx="12715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0     25    50    100</a:t>
            </a:r>
            <a:endParaRPr lang="en-US" sz="1200" baseline="-25000" dirty="0"/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48F103DC-9E27-E407-653C-A1181071B8FE}"/>
              </a:ext>
            </a:extLst>
          </p:cNvPr>
          <p:cNvCxnSpPr>
            <a:cxnSpLocks/>
          </p:cNvCxnSpPr>
          <p:nvPr/>
        </p:nvCxnSpPr>
        <p:spPr>
          <a:xfrm>
            <a:off x="2379779" y="1928685"/>
            <a:ext cx="108523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5B77E42A-7E37-A443-AE43-FBCC51AB6E10}"/>
              </a:ext>
            </a:extLst>
          </p:cNvPr>
          <p:cNvSpPr txBox="1"/>
          <p:nvPr/>
        </p:nvSpPr>
        <p:spPr>
          <a:xfrm>
            <a:off x="2399361" y="1325908"/>
            <a:ext cx="11120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PPV5+APPHA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0B24CF91-B9F7-A06F-556D-2A589761B31B}"/>
              </a:ext>
            </a:extLst>
          </p:cNvPr>
          <p:cNvCxnSpPr>
            <a:cxnSpLocks/>
          </p:cNvCxnSpPr>
          <p:nvPr/>
        </p:nvCxnSpPr>
        <p:spPr>
          <a:xfrm flipV="1">
            <a:off x="2379779" y="1611173"/>
            <a:ext cx="1085233" cy="322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1C800949-A587-A208-1176-369C3B1AB8C1}"/>
              </a:ext>
            </a:extLst>
          </p:cNvPr>
          <p:cNvSpPr txBox="1"/>
          <p:nvPr/>
        </p:nvSpPr>
        <p:spPr>
          <a:xfrm>
            <a:off x="1593095" y="3723590"/>
            <a:ext cx="5990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FH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F7B1114-13AF-55C5-85D5-5C6E0B78AB0A}"/>
              </a:ext>
            </a:extLst>
          </p:cNvPr>
          <p:cNvSpPr txBox="1"/>
          <p:nvPr/>
        </p:nvSpPr>
        <p:spPr>
          <a:xfrm>
            <a:off x="1593095" y="2475628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PPH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AA05991-8993-0D37-CBE0-DF952D893B2A}"/>
              </a:ext>
            </a:extLst>
          </p:cNvPr>
          <p:cNvSpPr txBox="1"/>
          <p:nvPr/>
        </p:nvSpPr>
        <p:spPr>
          <a:xfrm>
            <a:off x="1860961" y="5138372"/>
            <a:ext cx="15968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P: anti-HA, IB: anti-HA</a:t>
            </a:r>
            <a:endParaRPr lang="en-US" sz="1200" baseline="-25000" dirty="0"/>
          </a:p>
        </p:txBody>
      </p:sp>
      <p:pic>
        <p:nvPicPr>
          <p:cNvPr id="28" name="Picture 27" descr="A close up of a dna&#10;&#10;Description automatically generated">
            <a:extLst>
              <a:ext uri="{FF2B5EF4-FFF2-40B4-BE49-F238E27FC236}">
                <a16:creationId xmlns:a16="http://schemas.microsoft.com/office/drawing/2014/main" id="{CA9F46B9-DD56-7C6E-45A2-7FD810B4228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8333"/>
          <a:stretch/>
        </p:blipFill>
        <p:spPr>
          <a:xfrm>
            <a:off x="7024251" y="1017864"/>
            <a:ext cx="3306788" cy="5411451"/>
          </a:xfrm>
          <a:prstGeom prst="rect">
            <a:avLst/>
          </a:prstGeom>
        </p:spPr>
      </p:pic>
      <p:sp>
        <p:nvSpPr>
          <p:cNvPr id="29" name="Rectangle 28">
            <a:extLst>
              <a:ext uri="{FF2B5EF4-FFF2-40B4-BE49-F238E27FC236}">
                <a16:creationId xmlns:a16="http://schemas.microsoft.com/office/drawing/2014/main" id="{945D73BE-6530-C09F-5BC1-176DBED21A77}"/>
              </a:ext>
            </a:extLst>
          </p:cNvPr>
          <p:cNvSpPr/>
          <p:nvPr/>
        </p:nvSpPr>
        <p:spPr>
          <a:xfrm>
            <a:off x="8017965" y="2221439"/>
            <a:ext cx="1361358" cy="690213"/>
          </a:xfrm>
          <a:prstGeom prst="rect">
            <a:avLst/>
          </a:prstGeom>
          <a:noFill/>
          <a:ln w="4445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C49B8B03-0F7C-0B49-4BFD-2EC963A26761}"/>
              </a:ext>
            </a:extLst>
          </p:cNvPr>
          <p:cNvSpPr/>
          <p:nvPr/>
        </p:nvSpPr>
        <p:spPr>
          <a:xfrm>
            <a:off x="8019352" y="3376351"/>
            <a:ext cx="1365750" cy="789208"/>
          </a:xfrm>
          <a:prstGeom prst="rect">
            <a:avLst/>
          </a:prstGeom>
          <a:noFill/>
          <a:ln w="4445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05EC5B8-050D-FD7B-0244-FB0224C29F42}"/>
              </a:ext>
            </a:extLst>
          </p:cNvPr>
          <p:cNvSpPr txBox="1"/>
          <p:nvPr/>
        </p:nvSpPr>
        <p:spPr>
          <a:xfrm>
            <a:off x="7248440" y="3639438"/>
            <a:ext cx="7849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CTFmGFP</a:t>
            </a:r>
            <a:endParaRPr lang="en-US" sz="12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79C703F-56A0-FCFC-C654-614B34873E1E}"/>
              </a:ext>
            </a:extLst>
          </p:cNvPr>
          <p:cNvSpPr txBox="1"/>
          <p:nvPr/>
        </p:nvSpPr>
        <p:spPr>
          <a:xfrm>
            <a:off x="7225210" y="2428845"/>
            <a:ext cx="8066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APPmGFP</a:t>
            </a:r>
            <a:endParaRPr lang="en-US" sz="12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9B8F67B-3E29-9D66-01F4-36C4445A387D}"/>
              </a:ext>
            </a:extLst>
          </p:cNvPr>
          <p:cNvSpPr txBox="1"/>
          <p:nvPr/>
        </p:nvSpPr>
        <p:spPr>
          <a:xfrm>
            <a:off x="7889336" y="1457119"/>
            <a:ext cx="17133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APP-mGFP+APPmCherry</a:t>
            </a:r>
            <a:endParaRPr lang="en-US" sz="1200" baseline="-25000" dirty="0"/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0E7D9F1E-BE70-CB2F-D713-04F6A461226C}"/>
              </a:ext>
            </a:extLst>
          </p:cNvPr>
          <p:cNvCxnSpPr/>
          <p:nvPr/>
        </p:nvCxnSpPr>
        <p:spPr>
          <a:xfrm>
            <a:off x="8204081" y="1773868"/>
            <a:ext cx="94759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7CF83F88-E86D-4547-640B-7066583D610C}"/>
              </a:ext>
            </a:extLst>
          </p:cNvPr>
          <p:cNvSpPr txBox="1"/>
          <p:nvPr/>
        </p:nvSpPr>
        <p:spPr>
          <a:xfrm>
            <a:off x="8769224" y="1737773"/>
            <a:ext cx="3962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Cer</a:t>
            </a:r>
            <a:endParaRPr lang="en-US" sz="1200" baseline="-250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97EFCB8-219E-423E-20D2-034A2D99A0C0}"/>
              </a:ext>
            </a:extLst>
          </p:cNvPr>
          <p:cNvSpPr txBox="1"/>
          <p:nvPr/>
        </p:nvSpPr>
        <p:spPr>
          <a:xfrm>
            <a:off x="8116106" y="1725740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MSO</a:t>
            </a:r>
            <a:endParaRPr lang="en-US" sz="1200" baseline="-25000" dirty="0"/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23DD3FC8-6D0A-EFA2-E5D6-90CC614DA44C}"/>
              </a:ext>
            </a:extLst>
          </p:cNvPr>
          <p:cNvCxnSpPr>
            <a:cxnSpLocks/>
          </p:cNvCxnSpPr>
          <p:nvPr/>
        </p:nvCxnSpPr>
        <p:spPr>
          <a:xfrm>
            <a:off x="8021281" y="1989707"/>
            <a:ext cx="57501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6D19E8A9-1CC5-52C6-8D67-293CA5DEC779}"/>
              </a:ext>
            </a:extLst>
          </p:cNvPr>
          <p:cNvCxnSpPr>
            <a:cxnSpLocks/>
          </p:cNvCxnSpPr>
          <p:nvPr/>
        </p:nvCxnSpPr>
        <p:spPr>
          <a:xfrm>
            <a:off x="8730923" y="1980536"/>
            <a:ext cx="57501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B2D4DDD4-6EB7-2D84-009A-6CE1AE9CB3EE}"/>
              </a:ext>
            </a:extLst>
          </p:cNvPr>
          <p:cNvSpPr txBox="1"/>
          <p:nvPr/>
        </p:nvSpPr>
        <p:spPr>
          <a:xfrm>
            <a:off x="7432169" y="5099153"/>
            <a:ext cx="19484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P: anti-</a:t>
            </a:r>
            <a:r>
              <a:rPr lang="en-US" sz="1200" dirty="0" err="1"/>
              <a:t>mGFP</a:t>
            </a:r>
            <a:r>
              <a:rPr lang="en-US" sz="1200" dirty="0"/>
              <a:t>, IB: anti-</a:t>
            </a:r>
            <a:r>
              <a:rPr lang="en-US" sz="1200" dirty="0" err="1"/>
              <a:t>mGFP</a:t>
            </a:r>
            <a:endParaRPr lang="en-US" sz="1200" baseline="-250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6194D0C-4A9D-0215-9F02-EF5BA128E9DF}"/>
              </a:ext>
            </a:extLst>
          </p:cNvPr>
          <p:cNvSpPr txBox="1"/>
          <p:nvPr/>
        </p:nvSpPr>
        <p:spPr>
          <a:xfrm>
            <a:off x="0" y="18203"/>
            <a:ext cx="38186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Figure 6 Middle Gels (Full blots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5BDC999-FCF3-09B8-00D4-093709F0EB07}"/>
              </a:ext>
            </a:extLst>
          </p:cNvPr>
          <p:cNvSpPr txBox="1"/>
          <p:nvPr/>
        </p:nvSpPr>
        <p:spPr>
          <a:xfrm>
            <a:off x="2542082" y="589028"/>
            <a:ext cx="1069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6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18BA7D3-5CF4-72DA-35A1-88EBD7E566A7}"/>
              </a:ext>
            </a:extLst>
          </p:cNvPr>
          <p:cNvSpPr txBox="1"/>
          <p:nvPr/>
        </p:nvSpPr>
        <p:spPr>
          <a:xfrm>
            <a:off x="8098345" y="510712"/>
            <a:ext cx="1061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6B</a:t>
            </a:r>
          </a:p>
        </p:txBody>
      </p:sp>
    </p:spTree>
    <p:extLst>
      <p:ext uri="{BB962C8B-B14F-4D97-AF65-F5344CB8AC3E}">
        <p14:creationId xmlns:p14="http://schemas.microsoft.com/office/powerpoint/2010/main" val="1578277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04</TotalTime>
  <Words>123</Words>
  <Application>Microsoft Macintosh PowerPoint</Application>
  <PresentationFormat>Widescreen</PresentationFormat>
  <Paragraphs>42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hattacharyya, Raja,PHD</dc:creator>
  <cp:lastModifiedBy>Bhattacharyya, Raja,Ph.D.</cp:lastModifiedBy>
  <cp:revision>45</cp:revision>
  <dcterms:created xsi:type="dcterms:W3CDTF">2022-09-21T00:40:25Z</dcterms:created>
  <dcterms:modified xsi:type="dcterms:W3CDTF">2024-02-16T18:06:49Z</dcterms:modified>
</cp:coreProperties>
</file>